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22860000" cy="2743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640">
          <p15:clr>
            <a:srgbClr val="A4A3A4"/>
          </p15:clr>
        </p15:guide>
        <p15:guide id="2" pos="720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ynak, Ahmet (kaynakat)" initials="KA(" lastIdx="9" clrIdx="0">
    <p:extLst>
      <p:ext uri="{19B8F6BF-5375-455C-9EA6-DF929625EA0E}">
        <p15:presenceInfo xmlns:p15="http://schemas.microsoft.com/office/powerpoint/2012/main" userId="S::kaynakat@mail.uc.edu::e30822f5-f881-493f-bf88-3d523b0e27a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36" autoAdjust="0"/>
    <p:restoredTop sz="96973" autoAdjust="0"/>
  </p:normalViewPr>
  <p:slideViewPr>
    <p:cSldViewPr snapToGrid="0">
      <p:cViewPr>
        <p:scale>
          <a:sx n="75" d="100"/>
          <a:sy n="75" d="100"/>
        </p:scale>
        <p:origin x="940" y="-2892"/>
      </p:cViewPr>
      <p:guideLst>
        <p:guide orient="horz" pos="8640"/>
        <p:guide pos="72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ynak, Ahmet (kaynakat)" userId="e30822f5-f881-493f-bf88-3d523b0e27a6" providerId="ADAL" clId="{A688392A-46ED-49BB-9358-33E667A1B0C1}"/>
    <pc:docChg chg="modSld">
      <pc:chgData name="Kaynak, Ahmet (kaynakat)" userId="e30822f5-f881-493f-bf88-3d523b0e27a6" providerId="ADAL" clId="{A688392A-46ED-49BB-9358-33E667A1B0C1}" dt="2025-01-27T18:04:50.115" v="17" actId="20577"/>
      <pc:docMkLst>
        <pc:docMk/>
      </pc:docMkLst>
      <pc:sldChg chg="modSp mod">
        <pc:chgData name="Kaynak, Ahmet (kaynakat)" userId="e30822f5-f881-493f-bf88-3d523b0e27a6" providerId="ADAL" clId="{A688392A-46ED-49BB-9358-33E667A1B0C1}" dt="2025-01-27T18:04:50.115" v="17" actId="20577"/>
        <pc:sldMkLst>
          <pc:docMk/>
          <pc:sldMk cId="2845567764" sldId="267"/>
        </pc:sldMkLst>
        <pc:spChg chg="mod">
          <ac:chgData name="Kaynak, Ahmet (kaynakat)" userId="e30822f5-f881-493f-bf88-3d523b0e27a6" providerId="ADAL" clId="{A688392A-46ED-49BB-9358-33E667A1B0C1}" dt="2025-01-27T18:03:56.271" v="2" actId="1076"/>
          <ac:spMkLst>
            <pc:docMk/>
            <pc:sldMk cId="2845567764" sldId="267"/>
            <ac:spMk id="3" creationId="{ECE08D61-9773-09DA-7CCB-2E3873CA66B9}"/>
          </ac:spMkLst>
        </pc:spChg>
        <pc:spChg chg="mod">
          <ac:chgData name="Kaynak, Ahmet (kaynakat)" userId="e30822f5-f881-493f-bf88-3d523b0e27a6" providerId="ADAL" clId="{A688392A-46ED-49BB-9358-33E667A1B0C1}" dt="2025-01-27T18:04:50.115" v="17" actId="20577"/>
          <ac:spMkLst>
            <pc:docMk/>
            <pc:sldMk cId="2845567764" sldId="267"/>
            <ac:spMk id="7" creationId="{F68F054C-7333-964C-FEE2-4D4A039A1BD7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AD8B76-510C-5840-AFF8-56732EE74642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143000"/>
            <a:ext cx="2571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0FCF20-DC62-4C47-927D-B0873A9B0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6614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14500" y="4489452"/>
            <a:ext cx="19431000" cy="9550400"/>
          </a:xfrm>
        </p:spPr>
        <p:txBody>
          <a:bodyPr anchor="b"/>
          <a:lstStyle>
            <a:lvl1pPr algn="ctr">
              <a:defRPr sz="15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857500" y="14408152"/>
            <a:ext cx="17145000" cy="6623048"/>
          </a:xfrm>
        </p:spPr>
        <p:txBody>
          <a:bodyPr/>
          <a:lstStyle>
            <a:lvl1pPr marL="0" indent="0" algn="ctr">
              <a:buNone/>
              <a:defRPr sz="6000"/>
            </a:lvl1pPr>
            <a:lvl2pPr marL="1143000" indent="0" algn="ctr">
              <a:buNone/>
              <a:defRPr sz="5000"/>
            </a:lvl2pPr>
            <a:lvl3pPr marL="2286000" indent="0" algn="ctr">
              <a:buNone/>
              <a:defRPr sz="4500"/>
            </a:lvl3pPr>
            <a:lvl4pPr marL="3429000" indent="0" algn="ctr">
              <a:buNone/>
              <a:defRPr sz="4000"/>
            </a:lvl4pPr>
            <a:lvl5pPr marL="4572000" indent="0" algn="ctr">
              <a:buNone/>
              <a:defRPr sz="4000"/>
            </a:lvl5pPr>
            <a:lvl6pPr marL="5715000" indent="0" algn="ctr">
              <a:buNone/>
              <a:defRPr sz="4000"/>
            </a:lvl6pPr>
            <a:lvl7pPr marL="6858000" indent="0" algn="ctr">
              <a:buNone/>
              <a:defRPr sz="4000"/>
            </a:lvl7pPr>
            <a:lvl8pPr marL="8001000" indent="0" algn="ctr">
              <a:buNone/>
              <a:defRPr sz="4000"/>
            </a:lvl8pPr>
            <a:lvl9pPr marL="9144000" indent="0" algn="ctr">
              <a:buNone/>
              <a:defRPr sz="40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989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833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6359189" y="1460500"/>
            <a:ext cx="4929188" cy="2324735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571626" y="1460500"/>
            <a:ext cx="14501813" cy="2324735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148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2887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59720" y="6838958"/>
            <a:ext cx="19716750" cy="11410948"/>
          </a:xfrm>
        </p:spPr>
        <p:txBody>
          <a:bodyPr anchor="b"/>
          <a:lstStyle>
            <a:lvl1pPr>
              <a:defRPr sz="15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59720" y="18357858"/>
            <a:ext cx="19716750" cy="6000748"/>
          </a:xfrm>
        </p:spPr>
        <p:txBody>
          <a:bodyPr/>
          <a:lstStyle>
            <a:lvl1pPr marL="0" indent="0">
              <a:buNone/>
              <a:defRPr sz="6000">
                <a:solidFill>
                  <a:schemeClr val="tx1"/>
                </a:solidFill>
              </a:defRPr>
            </a:lvl1pPr>
            <a:lvl2pPr marL="1143000" indent="0">
              <a:buNone/>
              <a:defRPr sz="5000">
                <a:solidFill>
                  <a:schemeClr val="tx1">
                    <a:tint val="75000"/>
                  </a:schemeClr>
                </a:solidFill>
              </a:defRPr>
            </a:lvl2pPr>
            <a:lvl3pPr marL="2286000" indent="0">
              <a:buNone/>
              <a:defRPr sz="4500">
                <a:solidFill>
                  <a:schemeClr val="tx1">
                    <a:tint val="75000"/>
                  </a:schemeClr>
                </a:solidFill>
              </a:defRPr>
            </a:lvl3pPr>
            <a:lvl4pPr marL="3429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4pPr>
            <a:lvl5pPr marL="4572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5pPr>
            <a:lvl6pPr marL="5715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6pPr>
            <a:lvl7pPr marL="6858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7pPr>
            <a:lvl8pPr marL="8001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8pPr>
            <a:lvl9pPr marL="9144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646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71625" y="7302500"/>
            <a:ext cx="9715500" cy="17405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572875" y="7302500"/>
            <a:ext cx="9715500" cy="17405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387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1460506"/>
            <a:ext cx="19716750" cy="53022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74605" y="6724652"/>
            <a:ext cx="9670850" cy="3295648"/>
          </a:xfrm>
        </p:spPr>
        <p:txBody>
          <a:bodyPr anchor="b"/>
          <a:lstStyle>
            <a:lvl1pPr marL="0" indent="0">
              <a:buNone/>
              <a:defRPr sz="6000" b="1"/>
            </a:lvl1pPr>
            <a:lvl2pPr marL="1143000" indent="0">
              <a:buNone/>
              <a:defRPr sz="5000" b="1"/>
            </a:lvl2pPr>
            <a:lvl3pPr marL="2286000" indent="0">
              <a:buNone/>
              <a:defRPr sz="4500" b="1"/>
            </a:lvl3pPr>
            <a:lvl4pPr marL="3429000" indent="0">
              <a:buNone/>
              <a:defRPr sz="4000" b="1"/>
            </a:lvl4pPr>
            <a:lvl5pPr marL="4572000" indent="0">
              <a:buNone/>
              <a:defRPr sz="4000" b="1"/>
            </a:lvl5pPr>
            <a:lvl6pPr marL="5715000" indent="0">
              <a:buNone/>
              <a:defRPr sz="4000" b="1"/>
            </a:lvl6pPr>
            <a:lvl7pPr marL="6858000" indent="0">
              <a:buNone/>
              <a:defRPr sz="4000" b="1"/>
            </a:lvl7pPr>
            <a:lvl8pPr marL="8001000" indent="0">
              <a:buNone/>
              <a:defRPr sz="4000" b="1"/>
            </a:lvl8pPr>
            <a:lvl9pPr marL="9144000" indent="0">
              <a:buNone/>
              <a:defRPr sz="4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74605" y="10020300"/>
            <a:ext cx="9670850" cy="14738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1572876" y="6724652"/>
            <a:ext cx="9718478" cy="3295648"/>
          </a:xfrm>
        </p:spPr>
        <p:txBody>
          <a:bodyPr anchor="b"/>
          <a:lstStyle>
            <a:lvl1pPr marL="0" indent="0">
              <a:buNone/>
              <a:defRPr sz="6000" b="1"/>
            </a:lvl1pPr>
            <a:lvl2pPr marL="1143000" indent="0">
              <a:buNone/>
              <a:defRPr sz="5000" b="1"/>
            </a:lvl2pPr>
            <a:lvl3pPr marL="2286000" indent="0">
              <a:buNone/>
              <a:defRPr sz="4500" b="1"/>
            </a:lvl3pPr>
            <a:lvl4pPr marL="3429000" indent="0">
              <a:buNone/>
              <a:defRPr sz="4000" b="1"/>
            </a:lvl4pPr>
            <a:lvl5pPr marL="4572000" indent="0">
              <a:buNone/>
              <a:defRPr sz="4000" b="1"/>
            </a:lvl5pPr>
            <a:lvl6pPr marL="5715000" indent="0">
              <a:buNone/>
              <a:defRPr sz="4000" b="1"/>
            </a:lvl6pPr>
            <a:lvl7pPr marL="6858000" indent="0">
              <a:buNone/>
              <a:defRPr sz="4000" b="1"/>
            </a:lvl7pPr>
            <a:lvl8pPr marL="8001000" indent="0">
              <a:buNone/>
              <a:defRPr sz="4000" b="1"/>
            </a:lvl8pPr>
            <a:lvl9pPr marL="9144000" indent="0">
              <a:buNone/>
              <a:defRPr sz="4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1572876" y="10020300"/>
            <a:ext cx="9718478" cy="14738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682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708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436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1828800"/>
            <a:ext cx="7372945" cy="640080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718477" y="3949706"/>
            <a:ext cx="11572875" cy="19494500"/>
          </a:xfrm>
        </p:spPr>
        <p:txBody>
          <a:bodyPr/>
          <a:lstStyle>
            <a:lvl1pPr>
              <a:defRPr sz="8000"/>
            </a:lvl1pPr>
            <a:lvl2pPr>
              <a:defRPr sz="7000"/>
            </a:lvl2pPr>
            <a:lvl3pPr>
              <a:defRPr sz="6000"/>
            </a:lvl3pPr>
            <a:lvl4pPr>
              <a:defRPr sz="5000"/>
            </a:lvl4pPr>
            <a:lvl5pPr>
              <a:defRPr sz="5000"/>
            </a:lvl5pPr>
            <a:lvl6pPr>
              <a:defRPr sz="5000"/>
            </a:lvl6pPr>
            <a:lvl7pPr>
              <a:defRPr sz="5000"/>
            </a:lvl7pPr>
            <a:lvl8pPr>
              <a:defRPr sz="5000"/>
            </a:lvl8pPr>
            <a:lvl9pPr>
              <a:defRPr sz="5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74603" y="8229600"/>
            <a:ext cx="7372945" cy="15246352"/>
          </a:xfrm>
        </p:spPr>
        <p:txBody>
          <a:bodyPr/>
          <a:lstStyle>
            <a:lvl1pPr marL="0" indent="0">
              <a:buNone/>
              <a:defRPr sz="4000"/>
            </a:lvl1pPr>
            <a:lvl2pPr marL="1143000" indent="0">
              <a:buNone/>
              <a:defRPr sz="3500"/>
            </a:lvl2pPr>
            <a:lvl3pPr marL="2286000" indent="0">
              <a:buNone/>
              <a:defRPr sz="3000"/>
            </a:lvl3pPr>
            <a:lvl4pPr marL="3429000" indent="0">
              <a:buNone/>
              <a:defRPr sz="2500"/>
            </a:lvl4pPr>
            <a:lvl5pPr marL="4572000" indent="0">
              <a:buNone/>
              <a:defRPr sz="2500"/>
            </a:lvl5pPr>
            <a:lvl6pPr marL="5715000" indent="0">
              <a:buNone/>
              <a:defRPr sz="2500"/>
            </a:lvl6pPr>
            <a:lvl7pPr marL="6858000" indent="0">
              <a:buNone/>
              <a:defRPr sz="2500"/>
            </a:lvl7pPr>
            <a:lvl8pPr marL="8001000" indent="0">
              <a:buNone/>
              <a:defRPr sz="2500"/>
            </a:lvl8pPr>
            <a:lvl9pPr marL="9144000" indent="0">
              <a:buNone/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092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1828800"/>
            <a:ext cx="7372945" cy="640080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718477" y="3949706"/>
            <a:ext cx="11572875" cy="19494500"/>
          </a:xfrm>
        </p:spPr>
        <p:txBody>
          <a:bodyPr anchor="t"/>
          <a:lstStyle>
            <a:lvl1pPr marL="0" indent="0">
              <a:buNone/>
              <a:defRPr sz="8000"/>
            </a:lvl1pPr>
            <a:lvl2pPr marL="1143000" indent="0">
              <a:buNone/>
              <a:defRPr sz="7000"/>
            </a:lvl2pPr>
            <a:lvl3pPr marL="2286000" indent="0">
              <a:buNone/>
              <a:defRPr sz="6000"/>
            </a:lvl3pPr>
            <a:lvl4pPr marL="3429000" indent="0">
              <a:buNone/>
              <a:defRPr sz="5000"/>
            </a:lvl4pPr>
            <a:lvl5pPr marL="4572000" indent="0">
              <a:buNone/>
              <a:defRPr sz="5000"/>
            </a:lvl5pPr>
            <a:lvl6pPr marL="5715000" indent="0">
              <a:buNone/>
              <a:defRPr sz="5000"/>
            </a:lvl6pPr>
            <a:lvl7pPr marL="6858000" indent="0">
              <a:buNone/>
              <a:defRPr sz="5000"/>
            </a:lvl7pPr>
            <a:lvl8pPr marL="8001000" indent="0">
              <a:buNone/>
              <a:defRPr sz="5000"/>
            </a:lvl8pPr>
            <a:lvl9pPr marL="9144000" indent="0">
              <a:buNone/>
              <a:defRPr sz="5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74603" y="8229600"/>
            <a:ext cx="7372945" cy="15246352"/>
          </a:xfrm>
        </p:spPr>
        <p:txBody>
          <a:bodyPr/>
          <a:lstStyle>
            <a:lvl1pPr marL="0" indent="0">
              <a:buNone/>
              <a:defRPr sz="4000"/>
            </a:lvl1pPr>
            <a:lvl2pPr marL="1143000" indent="0">
              <a:buNone/>
              <a:defRPr sz="3500"/>
            </a:lvl2pPr>
            <a:lvl3pPr marL="2286000" indent="0">
              <a:buNone/>
              <a:defRPr sz="3000"/>
            </a:lvl3pPr>
            <a:lvl4pPr marL="3429000" indent="0">
              <a:buNone/>
              <a:defRPr sz="2500"/>
            </a:lvl4pPr>
            <a:lvl5pPr marL="4572000" indent="0">
              <a:buNone/>
              <a:defRPr sz="2500"/>
            </a:lvl5pPr>
            <a:lvl6pPr marL="5715000" indent="0">
              <a:buNone/>
              <a:defRPr sz="2500"/>
            </a:lvl6pPr>
            <a:lvl7pPr marL="6858000" indent="0">
              <a:buNone/>
              <a:defRPr sz="2500"/>
            </a:lvl7pPr>
            <a:lvl8pPr marL="8001000" indent="0">
              <a:buNone/>
              <a:defRPr sz="2500"/>
            </a:lvl8pPr>
            <a:lvl9pPr marL="9144000" indent="0">
              <a:buNone/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7097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571625" y="1460506"/>
            <a:ext cx="19716750" cy="53022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71625" y="7302500"/>
            <a:ext cx="19716750" cy="174053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571625" y="25425406"/>
            <a:ext cx="514350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572375" y="25425406"/>
            <a:ext cx="771525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144875" y="25425406"/>
            <a:ext cx="514350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7882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286000" rtl="0" eaLnBrk="1" latinLnBrk="0" hangingPunct="1">
        <a:lnSpc>
          <a:spcPct val="90000"/>
        </a:lnSpc>
        <a:spcBef>
          <a:spcPct val="0"/>
        </a:spcBef>
        <a:buNone/>
        <a:defRPr sz="11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71500" indent="-571500" algn="l" defTabSz="2286000" rtl="0" eaLnBrk="1" latinLnBrk="0" hangingPunct="1">
        <a:lnSpc>
          <a:spcPct val="90000"/>
        </a:lnSpc>
        <a:spcBef>
          <a:spcPts val="2500"/>
        </a:spcBef>
        <a:buFont typeface="Arial" panose="020B0604020202020204" pitchFamily="34" charset="0"/>
        <a:buChar char="•"/>
        <a:defRPr sz="7000" kern="1200">
          <a:solidFill>
            <a:schemeClr val="tx1"/>
          </a:solidFill>
          <a:latin typeface="+mn-lt"/>
          <a:ea typeface="+mn-ea"/>
          <a:cs typeface="+mn-cs"/>
        </a:defRPr>
      </a:lvl1pPr>
      <a:lvl2pPr marL="1714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2pPr>
      <a:lvl3pPr marL="2857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5000" kern="1200">
          <a:solidFill>
            <a:schemeClr val="tx1"/>
          </a:solidFill>
          <a:latin typeface="+mn-lt"/>
          <a:ea typeface="+mn-ea"/>
          <a:cs typeface="+mn-cs"/>
        </a:defRPr>
      </a:lvl3pPr>
      <a:lvl4pPr marL="4000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4pPr>
      <a:lvl5pPr marL="5143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5pPr>
      <a:lvl6pPr marL="6286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6pPr>
      <a:lvl7pPr marL="7429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7pPr>
      <a:lvl8pPr marL="8572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8pPr>
      <a:lvl9pPr marL="9715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143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3pPr>
      <a:lvl4pPr marL="3429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4pPr>
      <a:lvl5pPr marL="4572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5pPr>
      <a:lvl6pPr marL="5715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6pPr>
      <a:lvl7pPr marL="6858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7pPr>
      <a:lvl8pPr marL="8001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8pPr>
      <a:lvl9pPr marL="9144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6A72E21-3781-4BC7-8CDF-66718D4828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295656"/>
              </p:ext>
            </p:extLst>
          </p:nvPr>
        </p:nvGraphicFramePr>
        <p:xfrm>
          <a:off x="2546457" y="5845272"/>
          <a:ext cx="16664776" cy="12929800"/>
        </p:xfrm>
        <a:graphic>
          <a:graphicData uri="http://schemas.openxmlformats.org/drawingml/2006/table">
            <a:tbl>
              <a:tblPr firstRow="1" bandRow="1"/>
              <a:tblGrid>
                <a:gridCol w="3782639">
                  <a:extLst>
                    <a:ext uri="{9D8B030D-6E8A-4147-A177-3AD203B41FA5}">
                      <a16:colId xmlns:a16="http://schemas.microsoft.com/office/drawing/2014/main" val="3897014880"/>
                    </a:ext>
                  </a:extLst>
                </a:gridCol>
                <a:gridCol w="1288677">
                  <a:extLst>
                    <a:ext uri="{9D8B030D-6E8A-4147-A177-3AD203B41FA5}">
                      <a16:colId xmlns:a16="http://schemas.microsoft.com/office/drawing/2014/main" val="2677257379"/>
                    </a:ext>
                  </a:extLst>
                </a:gridCol>
                <a:gridCol w="1420876">
                  <a:extLst>
                    <a:ext uri="{9D8B030D-6E8A-4147-A177-3AD203B41FA5}">
                      <a16:colId xmlns:a16="http://schemas.microsoft.com/office/drawing/2014/main" val="364434854"/>
                    </a:ext>
                  </a:extLst>
                </a:gridCol>
                <a:gridCol w="1103580">
                  <a:extLst>
                    <a:ext uri="{9D8B030D-6E8A-4147-A177-3AD203B41FA5}">
                      <a16:colId xmlns:a16="http://schemas.microsoft.com/office/drawing/2014/main" val="2959206078"/>
                    </a:ext>
                  </a:extLst>
                </a:gridCol>
                <a:gridCol w="9069004">
                  <a:extLst>
                    <a:ext uri="{9D8B030D-6E8A-4147-A177-3AD203B41FA5}">
                      <a16:colId xmlns:a16="http://schemas.microsoft.com/office/drawing/2014/main" val="3465547226"/>
                    </a:ext>
                  </a:extLst>
                </a:gridCol>
              </a:tblGrid>
              <a:tr h="1163112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kine/Chemokine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P-1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P-1+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i36 EMD-CM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i36 EMD-CM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nction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350483151"/>
                  </a:ext>
                </a:extLst>
              </a:tr>
              <a:tr h="53269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P1(CCL2)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crophage recruitment/ M2 polarization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4157915874"/>
                  </a:ext>
                </a:extLst>
              </a:tr>
              <a:tr h="847906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5 (</a:t>
                      </a:r>
                      <a:r>
                        <a:rPr lang="en-US" sz="28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tes</a:t>
                      </a:r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crophage recruitment/ M2 polarization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3654130765"/>
                  </a:ext>
                </a:extLst>
              </a:tr>
              <a:tr h="847906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5(C5A)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moattractant, cell recruitment, C5AR expressed on M2 TAMs metastasis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752540661"/>
                  </a:ext>
                </a:extLst>
              </a:tr>
              <a:tr h="53269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CSF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ulopoiesis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2382064636"/>
                  </a:ext>
                </a:extLst>
              </a:tr>
              <a:tr h="53269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-CSF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ocyte, macrophage generation/M1 Phenotype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4294364861"/>
                  </a:ext>
                </a:extLst>
              </a:tr>
              <a:tr h="53269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eloid cell recruitment, Metastasis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3806143801"/>
                  </a:ext>
                </a:extLst>
              </a:tr>
              <a:tr h="53269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-RA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 Polarization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3311658707"/>
                  </a:ext>
                </a:extLst>
              </a:tr>
              <a:tr h="53269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A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 Polarization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2452451596"/>
                  </a:ext>
                </a:extLst>
              </a:tr>
              <a:tr h="53269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B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 Polarization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4185345681"/>
                  </a:ext>
                </a:extLst>
              </a:tr>
              <a:tr h="53269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 Polarization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2927271069"/>
                  </a:ext>
                </a:extLst>
              </a:tr>
              <a:tr h="53269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8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ogenesis/ Chemotaxis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879368689"/>
                  </a:ext>
                </a:extLst>
              </a:tr>
              <a:tr h="53269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CAM1(CD54)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2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motes angiogenesis/ M2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2586746151"/>
                  </a:ext>
                </a:extLst>
              </a:tr>
              <a:tr h="53269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ibitor of tissue plasminogen activator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960443552"/>
                  </a:ext>
                </a:extLst>
              </a:tr>
              <a:tr h="53269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F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suppressive/ M2/ Also proinflammatory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266905458"/>
                  </a:ext>
                </a:extLst>
              </a:tr>
              <a:tr h="53269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0 ligand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 Polarization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657777642"/>
                  </a:ext>
                </a:extLst>
              </a:tr>
              <a:tr h="739119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3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 Polarization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4066665363"/>
                  </a:ext>
                </a:extLst>
              </a:tr>
              <a:tr h="847906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3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 Polarization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1592893254"/>
                  </a:ext>
                </a:extLst>
              </a:tr>
              <a:tr h="847906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27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80776" marR="80776" marT="40389" marB="40389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 Polarization</a:t>
                      </a:r>
                    </a:p>
                  </a:txBody>
                  <a:tcPr marL="80776" marR="80776" marT="40389" marB="40389" anchor="ctr"/>
                </a:tc>
                <a:extLst>
                  <a:ext uri="{0D108BD9-81ED-4DB2-BD59-A6C34878D82A}">
                    <a16:rowId xmlns:a16="http://schemas.microsoft.com/office/drawing/2014/main" val="107756915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CE08D61-9773-09DA-7CCB-2E3873CA66B9}"/>
              </a:ext>
            </a:extLst>
          </p:cNvPr>
          <p:cNvSpPr txBox="1"/>
          <p:nvPr/>
        </p:nvSpPr>
        <p:spPr>
          <a:xfrm>
            <a:off x="2677109" y="5126835"/>
            <a:ext cx="21808425" cy="6612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</a:pPr>
            <a:r>
              <a:rPr lang="en-US" sz="28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able S1. Cancer cell EMD-CM-induced secretion profile of chemokines/cytokines from THP-1 cells. </a:t>
            </a:r>
            <a:endParaRPr lang="en-US" sz="2800" dirty="0">
              <a:effectLst/>
              <a:latin typeface="Times New Roman" panose="02020603050405020304" pitchFamily="18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68F054C-7333-964C-FEE2-4D4A039A1BD7}"/>
              </a:ext>
            </a:extLst>
          </p:cNvPr>
          <p:cNvSpPr txBox="1"/>
          <p:nvPr/>
        </p:nvSpPr>
        <p:spPr>
          <a:xfrm>
            <a:off x="2392254" y="18956289"/>
            <a:ext cx="17073617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ecreted cytokines and chemokines by THP-1 cells in response to Gli36 EMD-CM. EMD-CM from untreated THP-1 cells or </a:t>
            </a:r>
            <a:r>
              <a:rPr lang="en-US" sz="28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Gli36 EMD-CM </a:t>
            </a:r>
            <a:r>
              <a:rPr lang="en-US" sz="2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reated THP-1 cells or </a:t>
            </a:r>
            <a:r>
              <a:rPr lang="en-US" sz="28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Gli36 EMD-CM </a:t>
            </a:r>
            <a:r>
              <a:rPr lang="en-US" sz="2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treated THP-1 cells were analyzed by human proteome array and specific secreted cytokines and chemokines are shown.</a:t>
            </a:r>
            <a:endParaRPr 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5567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62</TotalTime>
  <Words>223</Words>
  <Application>Microsoft Office PowerPoint</Application>
  <PresentationFormat>Custom</PresentationFormat>
  <Paragraphs>9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ynak, Ahmet (kaynakat)</dc:creator>
  <cp:lastModifiedBy>Kaynak, Ahmet (kaynakat)</cp:lastModifiedBy>
  <cp:revision>23</cp:revision>
  <dcterms:created xsi:type="dcterms:W3CDTF">2021-11-16T17:09:50Z</dcterms:created>
  <dcterms:modified xsi:type="dcterms:W3CDTF">2025-01-27T18:04:51Z</dcterms:modified>
</cp:coreProperties>
</file>